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635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150" y="1122415"/>
            <a:ext cx="9144900" cy="2387711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150" y="3602205"/>
            <a:ext cx="9144900" cy="1655839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5759" y="365142"/>
            <a:ext cx="2629158" cy="581210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83" y="365142"/>
            <a:ext cx="7735062" cy="581210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933" y="1709818"/>
            <a:ext cx="10516635" cy="285286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933" y="4589676"/>
            <a:ext cx="10516635" cy="150025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83" y="1825710"/>
            <a:ext cx="5182110" cy="435154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809" y="1825710"/>
            <a:ext cx="5182110" cy="435154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365142"/>
            <a:ext cx="10516635" cy="132562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871" y="1681241"/>
            <a:ext cx="5158295" cy="8239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871" y="2505191"/>
            <a:ext cx="5158295" cy="368475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809" y="1681241"/>
            <a:ext cx="5183698" cy="8239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809" y="2505191"/>
            <a:ext cx="5183698" cy="368475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457221"/>
            <a:ext cx="3932624" cy="1600274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698" y="987471"/>
            <a:ext cx="6172809" cy="48738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1" y="2057495"/>
            <a:ext cx="3932624" cy="381176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871" y="457221"/>
            <a:ext cx="3932624" cy="1600274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698" y="987471"/>
            <a:ext cx="6172809" cy="4873851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871" y="2057495"/>
            <a:ext cx="3932624" cy="381176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83" y="365142"/>
            <a:ext cx="10516635" cy="132562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83" y="1825710"/>
            <a:ext cx="10516635" cy="43515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83" y="6356645"/>
            <a:ext cx="2743470" cy="365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999" y="6356645"/>
            <a:ext cx="4115205" cy="365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1449" y="6356645"/>
            <a:ext cx="2743470" cy="365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36" name="组合 35"/>
          <p:cNvGrpSpPr/>
          <p:nvPr/>
        </p:nvGrpSpPr>
        <p:grpSpPr>
          <a:xfrm>
            <a:off x="406400" y="2021840"/>
            <a:ext cx="9702165" cy="2146300"/>
            <a:chOff x="640" y="3184"/>
            <a:chExt cx="15279" cy="3380"/>
          </a:xfrm>
        </p:grpSpPr>
        <p:sp>
          <p:nvSpPr>
            <p:cNvPr id="73" name="文本框 72"/>
            <p:cNvSpPr txBox="1"/>
            <p:nvPr/>
          </p:nvSpPr>
          <p:spPr>
            <a:xfrm>
              <a:off x="14754" y="3184"/>
              <a:ext cx="104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XCR7</a:t>
              </a:r>
              <a:r>
                <a:rPr lang="en-US" altLang="zh-CN" b="1"/>
                <a:t> </a:t>
              </a:r>
              <a:endParaRPr lang="en-US" altLang="zh-CN" b="1"/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14748" y="4501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AKT</a:t>
              </a:r>
              <a:endParaRPr lang="en-US" altLang="zh-CN" sz="1400" b="1"/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14719" y="4930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-AKT</a:t>
              </a:r>
              <a:endParaRPr lang="en-US" altLang="zh-CN" sz="1400" b="1"/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14871" y="5341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ERK</a:t>
              </a:r>
              <a:endParaRPr lang="en-US" altLang="zh-CN" sz="1400" b="1"/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14739" y="5716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p-ERK</a:t>
              </a:r>
              <a:endParaRPr lang="en-US" altLang="zh-CN" sz="1400" b="1"/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14789" y="3698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VEGF</a:t>
              </a:r>
              <a:endParaRPr lang="en-US" altLang="zh-CN" sz="1400" b="1"/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14775" y="4106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Ki67</a:t>
              </a:r>
              <a:endParaRPr lang="en-US" altLang="zh-CN" sz="1400" b="1"/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11312" y="4342"/>
              <a:ext cx="324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qRT-PCR, Western </a:t>
              </a:r>
              <a:r>
                <a:rPr lang="en-US" altLang="zh-CN" sz="1400" b="1"/>
                <a:t>blot</a:t>
              </a:r>
              <a:endParaRPr lang="en-US" altLang="zh-CN" sz="1400" b="1"/>
            </a:p>
          </p:txBody>
        </p:sp>
        <p:pic>
          <p:nvPicPr>
            <p:cNvPr id="5" name="图片 4" descr="s12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848" y="3281"/>
              <a:ext cx="1236" cy="1317"/>
            </a:xfrm>
            <a:prstGeom prst="rect">
              <a:avLst/>
            </a:prstGeom>
          </p:spPr>
        </p:pic>
        <p:pic>
          <p:nvPicPr>
            <p:cNvPr id="7" name="图片 6" descr="s1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47" y="4208"/>
              <a:ext cx="2326" cy="1294"/>
            </a:xfrm>
            <a:prstGeom prst="rect">
              <a:avLst/>
            </a:prstGeom>
          </p:spPr>
        </p:pic>
        <p:pic>
          <p:nvPicPr>
            <p:cNvPr id="9" name="图片 8" descr="s1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939" y="3832"/>
              <a:ext cx="1978" cy="1832"/>
            </a:xfrm>
            <a:prstGeom prst="rect">
              <a:avLst/>
            </a:prstGeom>
          </p:spPr>
        </p:pic>
        <p:pic>
          <p:nvPicPr>
            <p:cNvPr id="11" name="图片 10" descr="s1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40" y="4181"/>
              <a:ext cx="2117" cy="1258"/>
            </a:xfrm>
            <a:prstGeom prst="rect">
              <a:avLst/>
            </a:prstGeom>
          </p:spPr>
        </p:pic>
        <p:pic>
          <p:nvPicPr>
            <p:cNvPr id="14" name="图片 13" descr="s12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7167" y="3472"/>
              <a:ext cx="1236" cy="1317"/>
            </a:xfrm>
            <a:prstGeom prst="rect">
              <a:avLst/>
            </a:prstGeom>
          </p:spPr>
        </p:pic>
        <p:cxnSp>
          <p:nvCxnSpPr>
            <p:cNvPr id="15" name="直接箭头连接符 14"/>
            <p:cNvCxnSpPr/>
            <p:nvPr/>
          </p:nvCxnSpPr>
          <p:spPr>
            <a:xfrm>
              <a:off x="2848" y="4825"/>
              <a:ext cx="1594" cy="0"/>
            </a:xfrm>
            <a:prstGeom prst="straightConnector1">
              <a:avLst/>
            </a:prstGeom>
            <a:ln w="28575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箭头连接符 20"/>
            <p:cNvCxnSpPr/>
            <p:nvPr/>
          </p:nvCxnSpPr>
          <p:spPr>
            <a:xfrm>
              <a:off x="7178" y="4956"/>
              <a:ext cx="1594" cy="0"/>
            </a:xfrm>
            <a:prstGeom prst="straightConnector1">
              <a:avLst/>
            </a:prstGeom>
            <a:ln w="28575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箭头连接符 21"/>
            <p:cNvCxnSpPr/>
            <p:nvPr/>
          </p:nvCxnSpPr>
          <p:spPr>
            <a:xfrm flipV="1">
              <a:off x="10884" y="4930"/>
              <a:ext cx="3684" cy="26"/>
            </a:xfrm>
            <a:prstGeom prst="straightConnector1">
              <a:avLst/>
            </a:prstGeom>
            <a:ln w="28575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/>
            <p:cNvSpPr txBox="1"/>
            <p:nvPr/>
          </p:nvSpPr>
          <p:spPr>
            <a:xfrm>
              <a:off x="10905" y="5061"/>
              <a:ext cx="399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I</a:t>
              </a:r>
              <a:r>
                <a:rPr lang="en-US" altLang="zh-CN" sz="1400" b="1"/>
                <a:t>mmunohistochemical  analysis</a:t>
              </a:r>
              <a:endParaRPr lang="en-US" altLang="zh-CN" sz="1400" b="1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14773" y="6082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CD34</a:t>
              </a:r>
              <a:endParaRPr lang="en-US" altLang="zh-CN" sz="1400" b="1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708" y="5341"/>
              <a:ext cx="2153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colon  cells</a:t>
              </a:r>
              <a:endParaRPr lang="en-US" altLang="zh-CN" sz="1600" b="1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4806" y="5313"/>
              <a:ext cx="2153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nude mice</a:t>
              </a:r>
              <a:endParaRPr lang="en-US" altLang="zh-CN" sz="1600" b="1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7142" y="4947"/>
              <a:ext cx="205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After 7days</a:t>
              </a:r>
              <a:endParaRPr lang="en-US" altLang="zh-CN" sz="1400" b="1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6805" y="3184"/>
              <a:ext cx="259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 b="1"/>
                <a:t>miR-524-5p agomir</a:t>
              </a:r>
              <a:endParaRPr lang="en-US" altLang="zh-CN" sz="1400" b="1"/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9386" y="5513"/>
              <a:ext cx="2153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/>
                <a:t>tissue</a:t>
              </a:r>
              <a:endParaRPr lang="en-US" altLang="zh-CN" sz="1600" b="1"/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mQ0ZTc1NDczMWMwZWYwY2E5NjM4ODIyMmU3NDBkOTMifQ=="/>
  <p:tag name="KSO_WPP_MARK_KEY" val="f81f4145-228e-49ef-9136-83a45653e55c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</Words>
  <Application>WPS 演示</Application>
  <PresentationFormat>宽屏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王宇飞</dc:creator>
  <cp:lastModifiedBy>大飞哥</cp:lastModifiedBy>
  <cp:revision>30</cp:revision>
  <dcterms:created xsi:type="dcterms:W3CDTF">2022-11-03T09:53:00Z</dcterms:created>
  <dcterms:modified xsi:type="dcterms:W3CDTF">2022-11-03T15:52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4197718000542ADAAD6DE40647171E0</vt:lpwstr>
  </property>
  <property fmtid="{D5CDD505-2E9C-101B-9397-08002B2CF9AE}" pid="3" name="KSOProductBuildVer">
    <vt:lpwstr>2052-11.1.0.12358</vt:lpwstr>
  </property>
</Properties>
</file>